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58"/>
  </p:normalViewPr>
  <p:slideViewPr>
    <p:cSldViewPr snapToGrid="0">
      <p:cViewPr varScale="1">
        <p:scale>
          <a:sx n="120" d="100"/>
          <a:sy n="120" d="100"/>
        </p:scale>
        <p:origin x="80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3E154F-7709-7325-1615-236853666F1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05E451D-3520-8A3D-907D-AACF6D5F0BF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C5F578-2813-5F47-69BF-67E3927C42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961DF7-A3C6-EB47-A2CD-7F52D9FBFFEE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58F248-3BCF-B4F9-0961-57765D751D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41A83C-DA51-5703-A4A7-9E9E17D045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5411E-E722-D647-B846-FFE4DAD345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48533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567183-670E-B308-2000-160D380DD0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FB59739-C795-57D6-CA24-DC65126FD7C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6ADC79-9438-7F8F-A6A7-6AC94335E5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961DF7-A3C6-EB47-A2CD-7F52D9FBFFEE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0C7CEA-45F8-571A-0CAE-B3E379D192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267C3B-94B5-5F2A-712D-E3A542BB7F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5411E-E722-D647-B846-FFE4DAD345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23310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D7C5921-ACD8-FAA4-738E-8EB31AB07E5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E26AA74-C166-7C42-BED3-1E3593B6509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9C23FC-920E-FAD6-AFAC-FEA4CF4D44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961DF7-A3C6-EB47-A2CD-7F52D9FBFFEE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999BC3-C261-478C-9694-7E782CD161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640D79-1683-EBB8-BA75-EFD57F563E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5411E-E722-D647-B846-FFE4DAD345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31371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B0E6F4-A254-D147-58B2-661CAFC07B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7C77282-5293-6DEF-DEC0-E86FE2DD4A2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16D089-91B3-27E6-943F-8526E97AE4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961DF7-A3C6-EB47-A2CD-7F52D9FBFFEE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F97E1B-9C66-4197-1A64-740DD3A7B7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18C51A-7753-086C-9551-8B129354B3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5411E-E722-D647-B846-FFE4DAD345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48435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703CAE-D600-AE54-E57F-28C35BF0E7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85777DB-5CFB-33A0-397A-C98B36B7A1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2CE8AC-EFD7-4E7F-0189-52D75B3465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961DF7-A3C6-EB47-A2CD-7F52D9FBFFEE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9B280A-DB97-6F14-1E06-049EEFBB78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8CDDE0-0322-CB10-8462-A01D301398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5411E-E722-D647-B846-FFE4DAD345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57278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8D1517-3123-7AC3-CF31-1F1B391BEB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EEC21F8-F563-4B9E-92DF-38DF9E43E63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09A0E16-EB0E-C264-4F28-44B0E8F5BB6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CAFC1DF-4197-924B-A417-5CC544425A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961DF7-A3C6-EB47-A2CD-7F52D9FBFFEE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516B77C-5810-7C53-4AEC-516E67CC5F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4327E0E-7C56-8764-E08B-CCAD3F958F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5411E-E722-D647-B846-FFE4DAD345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07687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65950B-82E9-B5E7-0B2A-932D030CEA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F8E16C0-CBFE-6528-2E26-354E14C2DD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92B720C-C53A-4E10-AA04-F2A93B8517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0CCE9AF-313F-E737-19CB-E536AD045EA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E9FBD9C-F465-F836-B712-1DFA5131E5C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E5E83D9-5EC1-9338-0AB9-DA0CF8FF12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961DF7-A3C6-EB47-A2CD-7F52D9FBFFEE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EAB960E-0861-D4ED-192D-41A9A0B038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9419450-A518-375B-CAEB-5B3311E7A1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5411E-E722-D647-B846-FFE4DAD345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69351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9CBA1B-4B35-A92F-A57B-3EE0607D10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337F038-AD41-E411-CE3B-1E8D2D1606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961DF7-A3C6-EB47-A2CD-7F52D9FBFFEE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01715C1-361C-66C4-0AA9-A2FF71A14D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02CE109-36BF-3133-09BF-88E6D09136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5411E-E722-D647-B846-FFE4DAD345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3192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7002811-9FE1-F7B2-46A6-8B4C3BB65D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961DF7-A3C6-EB47-A2CD-7F52D9FBFFEE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438FE92-0FD1-90C9-EC54-D4395042E7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8F4DB71-E713-240E-0425-F655EA8251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5411E-E722-D647-B846-FFE4DAD345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05123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93316A-6984-DB05-ACDE-7BD62FE851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1BD707B-1FD9-B550-30DB-F99364AEC4F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86908BD-0DAC-BA69-4C3C-408FFD78FB3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D7377F9-3D4C-DB19-1A79-E3CA7F7E74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961DF7-A3C6-EB47-A2CD-7F52D9FBFFEE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2140175-1569-987E-8405-EBDBAAA538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A913128-1DA0-A509-FDFD-68B6E9DDD6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5411E-E722-D647-B846-FFE4DAD345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76552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057E8C-2201-6F77-4786-4BE5B6F7D4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82EB688-8F1C-6CBE-C206-28BED573041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CD72C5A-23D3-4878-4EE9-05B367DA3BB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70E484C-C9A4-7DDA-F5AD-2A9C63AA89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961DF7-A3C6-EB47-A2CD-7F52D9FBFFEE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BE78C69-EF38-6F27-55CF-C664FBEFD9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56F980A-FC51-0939-6A84-016276C15D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5411E-E722-D647-B846-FFE4DAD345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48993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ACEBE26-0804-BE39-EEDC-9FAC26E622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45DD189-DBB6-52CE-AC81-195F89D686B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07F3FF-3C48-B353-CDEF-8C9023F9EFB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A961DF7-A3C6-EB47-A2CD-7F52D9FBFFEE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75B6A2-6E4B-9DFF-6537-C23B1BF914D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23CE3D-467F-7928-B3F7-CF9DEE957F5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F45411E-E722-D647-B846-FFE4DAD345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73754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CAC0FB65-D4A7-FA38-2DA6-77FC85BAD74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71476" y="247135"/>
            <a:ext cx="6049048" cy="555421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C9AA145-87D5-952E-CFF4-3A973002680D}"/>
              </a:ext>
            </a:extLst>
          </p:cNvPr>
          <p:cNvSpPr txBox="1"/>
          <p:nvPr/>
        </p:nvSpPr>
        <p:spPr>
          <a:xfrm>
            <a:off x="3174171" y="5964534"/>
            <a:ext cx="609777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upplemental Figure 4.</a:t>
            </a:r>
            <a:r>
              <a:rPr lang="en-US" sz="12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1200" kern="100" dirty="0">
                <a:solidFill>
                  <a:schemeClr val="bg2">
                    <a:lumMod val="10000"/>
                  </a:schemeClr>
                </a:solidFill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Overall and Progression Free Survival Kaplan Meier curves for  the protein SPHK1 and  the compound S1P based on pre CRT (baseline) data adjusted by </a:t>
            </a:r>
            <a:r>
              <a:rPr lang="en-US" sz="1200" dirty="0">
                <a:solidFill>
                  <a:schemeClr val="bg2">
                    <a:lumMod val="10000"/>
                  </a:schemeClr>
                </a:solidFill>
              </a:rPr>
              <a:t>age, VPA and GTV T1 </a:t>
            </a:r>
            <a:r>
              <a:rPr lang="en-US" sz="1200" kern="100" dirty="0">
                <a:solidFill>
                  <a:schemeClr val="bg2">
                    <a:lumMod val="10000"/>
                  </a:schemeClr>
                </a:solidFill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 </a:t>
            </a:r>
            <a:endParaRPr lang="en-US" sz="1200" dirty="0">
              <a:solidFill>
                <a:schemeClr val="bg2">
                  <a:lumMod val="1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323542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37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rauze, Andra (NIH/NCI) [E]</dc:creator>
  <cp:lastModifiedBy>Krauze, Andra (NIH/NCI) [E]</cp:lastModifiedBy>
  <cp:revision>1</cp:revision>
  <dcterms:created xsi:type="dcterms:W3CDTF">2025-10-28T19:09:40Z</dcterms:created>
  <dcterms:modified xsi:type="dcterms:W3CDTF">2025-10-28T19:11:52Z</dcterms:modified>
</cp:coreProperties>
</file>